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media/image5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DB3C69-B289-409D-8A22-5C27A3725F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DD1A8-435E-4D4B-8707-15B09FA61D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306F2B-BD9E-41B9-9BB9-0830309685A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F0401-C014-4A99-A57E-8A17C9C19B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320C28-9ED1-4C54-8D87-0B1C159DA6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5F5426-ACEA-4E92-96AA-FC7E2D6C89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1DEE03-6804-4BA7-8A4D-610860AF05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32A50C-9D4C-4A1F-89F1-E4A5D16F7F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296F48-6AA2-4F48-8E08-DE76F852E6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9FFBB-02A6-4172-8AD1-659359A885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7E4206-766E-4D6C-8E82-B68E030C14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307DA9-6F12-40DD-8482-369AC69456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80BE390-8734-4091-92A6-3B4789FE6261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2.png"/><Relationship Id="rId5" Type="http://schemas.openxmlformats.org/officeDocument/2006/relationships/image" Target="../media/image4.wmf"/><Relationship Id="rId6" Type="http://schemas.openxmlformats.org/officeDocument/2006/relationships/image" Target="../media/image5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2"/>
          <p:cNvGrpSpPr/>
          <p:nvPr/>
        </p:nvGrpSpPr>
        <p:grpSpPr>
          <a:xfrm>
            <a:off x="84240" y="47520"/>
            <a:ext cx="6643440" cy="8629920"/>
            <a:chOff x="84240" y="47520"/>
            <a:chExt cx="6643440" cy="862992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tretch/>
          </p:blipFill>
          <p:spPr>
            <a:xfrm>
              <a:off x="592560" y="1497600"/>
              <a:ext cx="3081960" cy="225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3" name="CasellaDiTesto 5"/>
            <p:cNvSpPr/>
            <p:nvPr/>
          </p:nvSpPr>
          <p:spPr>
            <a:xfrm>
              <a:off x="3716640" y="1474560"/>
              <a:ext cx="985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nti-BCLXL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4" name="Picture 8" descr=""/>
            <p:cNvPicPr/>
            <p:nvPr/>
          </p:nvPicPr>
          <p:blipFill>
            <a:blip r:embed="rId2"/>
            <a:stretch/>
          </p:blipFill>
          <p:spPr>
            <a:xfrm>
              <a:off x="592560" y="1844280"/>
              <a:ext cx="3112560" cy="2314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5" name="CasellaDiTesto 5"/>
            <p:cNvSpPr/>
            <p:nvPr/>
          </p:nvSpPr>
          <p:spPr>
            <a:xfrm>
              <a:off x="3727800" y="1768320"/>
              <a:ext cx="1078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nti-tubulin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6" name="Picture 6" descr=""/>
            <p:cNvPicPr/>
            <p:nvPr/>
          </p:nvPicPr>
          <p:blipFill>
            <a:blip r:embed="rId3"/>
            <a:stretch/>
          </p:blipFill>
          <p:spPr>
            <a:xfrm>
              <a:off x="650880" y="5532840"/>
              <a:ext cx="3036240" cy="22320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sp>
          <p:nvSpPr>
            <p:cNvPr id="47" name="CasellaDiTesto 5"/>
            <p:cNvSpPr/>
            <p:nvPr/>
          </p:nvSpPr>
          <p:spPr>
            <a:xfrm>
              <a:off x="3732120" y="5487840"/>
              <a:ext cx="916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nti-FLIPL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8" name="Picture 8" descr=""/>
            <p:cNvPicPr/>
            <p:nvPr/>
          </p:nvPicPr>
          <p:blipFill>
            <a:blip r:embed="rId4"/>
            <a:stretch/>
          </p:blipFill>
          <p:spPr>
            <a:xfrm>
              <a:off x="650880" y="5860080"/>
              <a:ext cx="3054240" cy="2264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9" name="CasellaDiTesto 5"/>
            <p:cNvSpPr/>
            <p:nvPr/>
          </p:nvSpPr>
          <p:spPr>
            <a:xfrm>
              <a:off x="3785760" y="5814720"/>
              <a:ext cx="1078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nti-tubulin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CasellaDiTesto 12"/>
            <p:cNvSpPr/>
            <p:nvPr/>
          </p:nvSpPr>
          <p:spPr>
            <a:xfrm>
              <a:off x="94320" y="47520"/>
              <a:ext cx="66333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igure S6.</a:t>
              </a:r>
              <a:r>
                <a:rPr b="1" lang="en-GB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Antiapoptotic proteins BCLXL and FLIP were not differentially expressed in Th1 and Th17 cells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1" name="Gruppo 1"/>
            <p:cNvGrpSpPr/>
            <p:nvPr/>
          </p:nvGrpSpPr>
          <p:grpSpPr>
            <a:xfrm>
              <a:off x="695880" y="886680"/>
              <a:ext cx="3804120" cy="703800"/>
              <a:chOff x="695880" y="886680"/>
              <a:chExt cx="3804120" cy="703800"/>
            </a:xfrm>
          </p:grpSpPr>
          <p:sp>
            <p:nvSpPr>
              <p:cNvPr id="52" name="CasellaDiTesto 14"/>
              <p:cNvSpPr/>
              <p:nvPr/>
            </p:nvSpPr>
            <p:spPr>
              <a:xfrm>
                <a:off x="723600" y="981360"/>
                <a:ext cx="771480" cy="581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r>
                  <a:rPr b="0" lang="it-IT" sz="3200" spc="-1" strike="noStrike">
                    <a:solidFill>
                      <a:srgbClr val="000000"/>
                    </a:solidFill>
                    <a:latin typeface="Calibri"/>
                  </a:rPr>
                  <a:t>   </a:t>
                </a: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2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CasellaDiTesto 15"/>
              <p:cNvSpPr/>
              <p:nvPr/>
            </p:nvSpPr>
            <p:spPr>
              <a:xfrm>
                <a:off x="1448640" y="987480"/>
                <a:ext cx="771480" cy="581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r>
                  <a:rPr b="0" lang="it-IT" sz="3200" spc="-1" strike="noStrike">
                    <a:solidFill>
                      <a:srgbClr val="000000"/>
                    </a:solidFill>
                    <a:latin typeface="Calibri"/>
                  </a:rPr>
                  <a:t>   </a:t>
                </a: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2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CasellaDiTesto 16"/>
              <p:cNvSpPr/>
              <p:nvPr/>
            </p:nvSpPr>
            <p:spPr>
              <a:xfrm>
                <a:off x="2189880" y="1009080"/>
                <a:ext cx="771480" cy="581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r>
                  <a:rPr b="0" lang="it-IT" sz="3200" spc="-1" strike="noStrike">
                    <a:solidFill>
                      <a:srgbClr val="000000"/>
                    </a:solidFill>
                    <a:latin typeface="Calibri"/>
                  </a:rPr>
                  <a:t>   </a:t>
                </a: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2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CasellaDiTesto 17"/>
              <p:cNvSpPr/>
              <p:nvPr/>
            </p:nvSpPr>
            <p:spPr>
              <a:xfrm>
                <a:off x="2915640" y="1009080"/>
                <a:ext cx="771480" cy="581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r>
                  <a:rPr b="0" lang="it-IT" sz="3200" spc="-1" strike="noStrike">
                    <a:solidFill>
                      <a:srgbClr val="000000"/>
                    </a:solidFill>
                    <a:latin typeface="Calibri"/>
                  </a:rPr>
                  <a:t>   </a:t>
                </a: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2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CasellaDiTesto 18"/>
              <p:cNvSpPr/>
              <p:nvPr/>
            </p:nvSpPr>
            <p:spPr>
              <a:xfrm>
                <a:off x="3624480" y="1199160"/>
                <a:ext cx="875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antiCD3-28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CasellaDiTesto 19"/>
              <p:cNvSpPr/>
              <p:nvPr/>
            </p:nvSpPr>
            <p:spPr>
              <a:xfrm>
                <a:off x="803880" y="886680"/>
                <a:ext cx="6012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Calibri"/>
                  </a:rPr>
                  <a:t>Th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CasellaDiTesto 20"/>
              <p:cNvSpPr/>
              <p:nvPr/>
            </p:nvSpPr>
            <p:spPr>
              <a:xfrm>
                <a:off x="1485720" y="899280"/>
                <a:ext cx="6012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Calibri"/>
                  </a:rPr>
                  <a:t>Th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CasellaDiTesto 21"/>
              <p:cNvSpPr/>
              <p:nvPr/>
            </p:nvSpPr>
            <p:spPr>
              <a:xfrm>
                <a:off x="2232360" y="916560"/>
                <a:ext cx="6012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Calibri"/>
                  </a:rPr>
                  <a:t>Th17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CasellaDiTesto 22"/>
              <p:cNvSpPr/>
              <p:nvPr/>
            </p:nvSpPr>
            <p:spPr>
              <a:xfrm>
                <a:off x="2894760" y="929880"/>
                <a:ext cx="880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Calibri"/>
                  </a:rPr>
                  <a:t>Th1/17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Connettore 1 23"/>
              <p:cNvSpPr/>
              <p:nvPr/>
            </p:nvSpPr>
            <p:spPr>
              <a:xfrm>
                <a:off x="695880" y="1260720"/>
                <a:ext cx="671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Connettore 1 24"/>
              <p:cNvSpPr/>
              <p:nvPr/>
            </p:nvSpPr>
            <p:spPr>
              <a:xfrm>
                <a:off x="1422360" y="1260720"/>
                <a:ext cx="671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Connettore 1 25"/>
              <p:cNvSpPr/>
              <p:nvPr/>
            </p:nvSpPr>
            <p:spPr>
              <a:xfrm>
                <a:off x="2161800" y="1260720"/>
                <a:ext cx="671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Connettore 1 26"/>
              <p:cNvSpPr/>
              <p:nvPr/>
            </p:nvSpPr>
            <p:spPr>
              <a:xfrm>
                <a:off x="2876040" y="1257840"/>
                <a:ext cx="671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5" name="Gruppo 28"/>
            <p:cNvGrpSpPr/>
            <p:nvPr/>
          </p:nvGrpSpPr>
          <p:grpSpPr>
            <a:xfrm>
              <a:off x="726480" y="4901400"/>
              <a:ext cx="3804120" cy="703800"/>
              <a:chOff x="726480" y="4901400"/>
              <a:chExt cx="3804120" cy="703800"/>
            </a:xfrm>
          </p:grpSpPr>
          <p:sp>
            <p:nvSpPr>
              <p:cNvPr id="66" name="CasellaDiTesto 29"/>
              <p:cNvSpPr/>
              <p:nvPr/>
            </p:nvSpPr>
            <p:spPr>
              <a:xfrm>
                <a:off x="754200" y="4996080"/>
                <a:ext cx="771480" cy="581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r>
                  <a:rPr b="0" lang="it-IT" sz="3200" spc="-1" strike="noStrike">
                    <a:solidFill>
                      <a:srgbClr val="000000"/>
                    </a:solidFill>
                    <a:latin typeface="Calibri"/>
                  </a:rPr>
                  <a:t>   </a:t>
                </a: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2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CasellaDiTesto 30"/>
              <p:cNvSpPr/>
              <p:nvPr/>
            </p:nvSpPr>
            <p:spPr>
              <a:xfrm>
                <a:off x="1479240" y="5002200"/>
                <a:ext cx="771480" cy="581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r>
                  <a:rPr b="0" lang="it-IT" sz="3200" spc="-1" strike="noStrike">
                    <a:solidFill>
                      <a:srgbClr val="000000"/>
                    </a:solidFill>
                    <a:latin typeface="Calibri"/>
                  </a:rPr>
                  <a:t>   </a:t>
                </a: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2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CasellaDiTesto 31"/>
              <p:cNvSpPr/>
              <p:nvPr/>
            </p:nvSpPr>
            <p:spPr>
              <a:xfrm>
                <a:off x="2220480" y="5023800"/>
                <a:ext cx="771480" cy="581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r>
                  <a:rPr b="0" lang="it-IT" sz="3200" spc="-1" strike="noStrike">
                    <a:solidFill>
                      <a:srgbClr val="000000"/>
                    </a:solidFill>
                    <a:latin typeface="Calibri"/>
                  </a:rPr>
                  <a:t>   </a:t>
                </a: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2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CasellaDiTesto 32"/>
              <p:cNvSpPr/>
              <p:nvPr/>
            </p:nvSpPr>
            <p:spPr>
              <a:xfrm>
                <a:off x="2946240" y="5023800"/>
                <a:ext cx="771480" cy="581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r>
                  <a:rPr b="0" lang="it-IT" sz="3200" spc="-1" strike="noStrike">
                    <a:solidFill>
                      <a:srgbClr val="000000"/>
                    </a:solidFill>
                    <a:latin typeface="Calibri"/>
                  </a:rPr>
                  <a:t>   </a:t>
                </a:r>
                <a:r>
                  <a:rPr b="0" lang="it-IT" sz="2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2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CasellaDiTesto 33"/>
              <p:cNvSpPr/>
              <p:nvPr/>
            </p:nvSpPr>
            <p:spPr>
              <a:xfrm>
                <a:off x="3655080" y="5213880"/>
                <a:ext cx="875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antiCD3-28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CasellaDiTesto 34"/>
              <p:cNvSpPr/>
              <p:nvPr/>
            </p:nvSpPr>
            <p:spPr>
              <a:xfrm>
                <a:off x="834480" y="4901400"/>
                <a:ext cx="6012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Calibri"/>
                  </a:rPr>
                  <a:t>Th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CasellaDiTesto 35"/>
              <p:cNvSpPr/>
              <p:nvPr/>
            </p:nvSpPr>
            <p:spPr>
              <a:xfrm>
                <a:off x="1516320" y="4914000"/>
                <a:ext cx="6012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Calibri"/>
                  </a:rPr>
                  <a:t>Th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CasellaDiTesto 36"/>
              <p:cNvSpPr/>
              <p:nvPr/>
            </p:nvSpPr>
            <p:spPr>
              <a:xfrm>
                <a:off x="2262960" y="4931280"/>
                <a:ext cx="6012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Calibri"/>
                  </a:rPr>
                  <a:t>Th17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CasellaDiTesto 37"/>
              <p:cNvSpPr/>
              <p:nvPr/>
            </p:nvSpPr>
            <p:spPr>
              <a:xfrm>
                <a:off x="2925360" y="4944600"/>
                <a:ext cx="880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Calibri"/>
                  </a:rPr>
                  <a:t>Th1/17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Connettore 1 38"/>
              <p:cNvSpPr/>
              <p:nvPr/>
            </p:nvSpPr>
            <p:spPr>
              <a:xfrm>
                <a:off x="726480" y="5275440"/>
                <a:ext cx="671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Connettore 1 39"/>
              <p:cNvSpPr/>
              <p:nvPr/>
            </p:nvSpPr>
            <p:spPr>
              <a:xfrm>
                <a:off x="1452960" y="5275440"/>
                <a:ext cx="671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Connettore 1 40"/>
              <p:cNvSpPr/>
              <p:nvPr/>
            </p:nvSpPr>
            <p:spPr>
              <a:xfrm>
                <a:off x="2192400" y="5275440"/>
                <a:ext cx="671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Connettore 1 41"/>
              <p:cNvSpPr/>
              <p:nvPr/>
            </p:nvSpPr>
            <p:spPr>
              <a:xfrm>
                <a:off x="2906640" y="5272560"/>
                <a:ext cx="671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9" name="CasellaDiTesto 42"/>
            <p:cNvSpPr/>
            <p:nvPr/>
          </p:nvSpPr>
          <p:spPr>
            <a:xfrm>
              <a:off x="111240" y="932040"/>
              <a:ext cx="383040" cy="429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22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2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CasellaDiTesto 43"/>
            <p:cNvSpPr/>
            <p:nvPr/>
          </p:nvSpPr>
          <p:spPr>
            <a:xfrm>
              <a:off x="84240" y="4698360"/>
              <a:ext cx="375120" cy="429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22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2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1" name="Immagine 27" descr=""/>
            <p:cNvPicPr/>
            <p:nvPr/>
          </p:nvPicPr>
          <p:blipFill>
            <a:blip r:embed="rId5"/>
            <a:stretch/>
          </p:blipFill>
          <p:spPr>
            <a:xfrm>
              <a:off x="186120" y="2481840"/>
              <a:ext cx="3501360" cy="2216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" name="Immagine 44" descr=""/>
            <p:cNvPicPr/>
            <p:nvPr/>
          </p:nvPicPr>
          <p:blipFill>
            <a:blip r:embed="rId6"/>
            <a:stretch/>
          </p:blipFill>
          <p:spPr>
            <a:xfrm>
              <a:off x="111240" y="6413760"/>
              <a:ext cx="3756960" cy="22636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3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06T09:00:15Z</dcterms:created>
  <dc:creator>Elisabetta Volpe</dc:creator>
  <dc:description/>
  <dc:language>en-US</dc:language>
  <cp:lastModifiedBy>ravikumar.n</cp:lastModifiedBy>
  <cp:lastPrinted>2014-09-23T08:26:44Z</cp:lastPrinted>
  <dcterms:modified xsi:type="dcterms:W3CDTF">2015-04-16T17:06:12Z</dcterms:modified>
  <cp:revision>106</cp:revision>
  <dc:subject/>
  <dc:title>Presentazione di PowerPoint</dc:title>
</cp:coreProperties>
</file>